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3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456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8AB9FB-A3BF-4351-A56E-16851DE506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087AEFC-94F1-4A51-9C19-C3760DEFBD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D364513-489E-4E5D-A5B1-7B0E5ADEE6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EFA5460-76AB-4ACB-A933-73DB1EC8B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02D96E-2E4F-4130-852D-141100BFB0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36911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9BE564-612D-4F00-B956-358C772BB1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2F4A9E5-5C33-4DFE-BF86-F1B6BFBD9C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ED2602C-E5D7-4621-99F7-2FA3AD4027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82D47E-BE8A-4400-99F0-B082439883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7D67C6A-383A-46BA-92DB-EEBF344BCC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7005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1E5994D-4D86-4B2A-9E6D-0EDE25CAAB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1754DFB-E776-430E-A8AE-9AB3190C24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8F1E31-5842-49EA-BF43-5F50426A75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ED8915D-9A4F-4852-A6CE-5D62E2067F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293E0AB-6D32-4912-8CB9-D5679B1F0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626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3C5B5F-04CD-4A31-BF93-EDBA3C03C6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4AFE711-A456-47BD-811A-811D11AB30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AC31404-7662-425E-81B1-B25B998B5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866F4D-53E3-4F2B-81DA-3139E47157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863A995-47D4-4C97-B9F4-24636F33FE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7605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9C3BABF-3BAA-4B33-A9B5-848A6C18F6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BF2DEED-0D03-44A0-AC38-9CD2F1285D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48060CA-2D0B-4BB6-8FE6-20D83E1993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7F1A841-EE5C-468D-BAA0-692D7E35B9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CFBE6EB-B969-4BBA-A70C-64DAEDC48A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6471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81170D-3F38-41D3-BDE1-34C7849763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0FC2D10-F0B9-42D6-A401-5EC16D8F13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7A8A471-CA1F-4B8B-B376-6DC1003536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AC62880-5BCF-47D9-9AFA-6155E23A3B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6B7102B-9046-4DE8-99A3-5BF6536BC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32CC358-9A27-480B-A13D-9970B72D0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7671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4030C1-76A0-4D90-B702-F2BFF55109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4765CC0-C2A1-477F-84DE-5C2B2FF8D7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5578798-2F6F-4BB0-ABB4-3D43D7B1DA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28A169F-62FC-40FF-8BDF-149B0DF4420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5C200EA-DF3C-4EC6-A928-B2AD73862CA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4ACA2BC-8D47-4CDC-889B-B0D32E97F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B77FB6A-EEC8-4436-8BE3-589C073DC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32E256F-526E-43C5-A334-1EC9F07C1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5923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10201C-295B-4D9F-8DAF-BC61605902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2333DD1-D3DA-49DF-8DEA-421DD7C9E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10CC7EB-1B3D-4F0D-B9FD-46580610BA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EE2C47C-27DE-4491-A7D8-00A53175D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5014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52CD53C-B473-4FF3-A36F-311590A8A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D5FED18-7D88-4FB7-AA54-68F85B8B6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3BCCF65-AA58-4954-95FE-A4ADFECF8E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7497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834C130-0E15-4BC4-A819-BD0933E32C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8D0FC64-EBD5-45B8-BEA5-B891769FE0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EB8DDFD-5502-4D70-9E68-2E9761A155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8D53EC4-B9F0-4FD7-B34F-CF9EE647E2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93760CF-89CB-47B8-8935-1D457855B6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263B2B8-7A70-4C8A-AF3E-D0477DD86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0902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98346C-310A-44ED-A03F-D36523545C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6D41416-CCA7-46EA-BC5F-2710F60613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2B4EB9F-E307-4892-ABAB-A7199764BA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89CDEA8-6D49-42FC-949E-34BA8DC037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B3CDFB9-F369-4E93-BE77-8FF754ECAB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AEC1A7E-52DA-4167-BF95-1D1ED60186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82187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AA6929B-79F2-4026-9AD9-11B15F80C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BDA2932-5098-4329-961B-E31EE3AA6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1B5AAF7-FE56-43DA-9DA3-746EFDEF77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9BA16D-90BA-422F-8DF4-BE1DBE3752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17E3BEA-392E-4DE2-A3E8-7B09096ABB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1821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Line 8">
            <a:extLst>
              <a:ext uri="{FF2B5EF4-FFF2-40B4-BE49-F238E27FC236}">
                <a16:creationId xmlns:a16="http://schemas.microsoft.com/office/drawing/2014/main" id="{C1A40E62-6D49-4EF4-BE9A-BC570C9F0027}"/>
              </a:ext>
            </a:extLst>
          </p:cNvPr>
          <p:cNvSpPr>
            <a:spLocks noChangeShapeType="1"/>
          </p:cNvSpPr>
          <p:nvPr/>
        </p:nvSpPr>
        <p:spPr bwMode="auto">
          <a:xfrm>
            <a:off x="3821420" y="4246843"/>
            <a:ext cx="396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Line 9">
            <a:extLst>
              <a:ext uri="{FF2B5EF4-FFF2-40B4-BE49-F238E27FC236}">
                <a16:creationId xmlns:a16="http://schemas.microsoft.com/office/drawing/2014/main" id="{2EA09076-668E-4BBC-8BE3-B43491458F06}"/>
              </a:ext>
            </a:extLst>
          </p:cNvPr>
          <p:cNvSpPr>
            <a:spLocks noChangeShapeType="1"/>
          </p:cNvSpPr>
          <p:nvPr/>
        </p:nvSpPr>
        <p:spPr bwMode="auto">
          <a:xfrm>
            <a:off x="3821420" y="3629305"/>
            <a:ext cx="396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Line 10">
            <a:extLst>
              <a:ext uri="{FF2B5EF4-FFF2-40B4-BE49-F238E27FC236}">
                <a16:creationId xmlns:a16="http://schemas.microsoft.com/office/drawing/2014/main" id="{B56E4B5F-0348-4DB3-9549-61EB5AFAF3AB}"/>
              </a:ext>
            </a:extLst>
          </p:cNvPr>
          <p:cNvSpPr>
            <a:spLocks noChangeShapeType="1"/>
          </p:cNvSpPr>
          <p:nvPr/>
        </p:nvSpPr>
        <p:spPr bwMode="auto">
          <a:xfrm>
            <a:off x="3821420" y="3011768"/>
            <a:ext cx="396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Line 11">
            <a:extLst>
              <a:ext uri="{FF2B5EF4-FFF2-40B4-BE49-F238E27FC236}">
                <a16:creationId xmlns:a16="http://schemas.microsoft.com/office/drawing/2014/main" id="{55D3B5B2-53F3-43A9-BEF1-F1BF660CC9CF}"/>
              </a:ext>
            </a:extLst>
          </p:cNvPr>
          <p:cNvSpPr>
            <a:spLocks noChangeShapeType="1"/>
          </p:cNvSpPr>
          <p:nvPr/>
        </p:nvSpPr>
        <p:spPr bwMode="auto">
          <a:xfrm>
            <a:off x="3821420" y="2392643"/>
            <a:ext cx="396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Line 12">
            <a:extLst>
              <a:ext uri="{FF2B5EF4-FFF2-40B4-BE49-F238E27FC236}">
                <a16:creationId xmlns:a16="http://schemas.microsoft.com/office/drawing/2014/main" id="{722B39C5-CE96-4540-A736-C152E84FEB7A}"/>
              </a:ext>
            </a:extLst>
          </p:cNvPr>
          <p:cNvSpPr>
            <a:spLocks noChangeShapeType="1"/>
          </p:cNvSpPr>
          <p:nvPr/>
        </p:nvSpPr>
        <p:spPr bwMode="auto">
          <a:xfrm>
            <a:off x="3821420" y="1775105"/>
            <a:ext cx="396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ine 13">
            <a:extLst>
              <a:ext uri="{FF2B5EF4-FFF2-40B4-BE49-F238E27FC236}">
                <a16:creationId xmlns:a16="http://schemas.microsoft.com/office/drawing/2014/main" id="{A2304D7E-ABC3-4576-BCB5-DC3FA1788416}"/>
              </a:ext>
            </a:extLst>
          </p:cNvPr>
          <p:cNvSpPr>
            <a:spLocks noChangeShapeType="1"/>
          </p:cNvSpPr>
          <p:nvPr/>
        </p:nvSpPr>
        <p:spPr bwMode="auto">
          <a:xfrm>
            <a:off x="3783320" y="4556405"/>
            <a:ext cx="777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Line 14">
            <a:extLst>
              <a:ext uri="{FF2B5EF4-FFF2-40B4-BE49-F238E27FC236}">
                <a16:creationId xmlns:a16="http://schemas.microsoft.com/office/drawing/2014/main" id="{3043B6F6-2B9B-4BCD-93F8-AB572B1555F4}"/>
              </a:ext>
            </a:extLst>
          </p:cNvPr>
          <p:cNvSpPr>
            <a:spLocks noChangeShapeType="1"/>
          </p:cNvSpPr>
          <p:nvPr/>
        </p:nvSpPr>
        <p:spPr bwMode="auto">
          <a:xfrm>
            <a:off x="3783320" y="3938868"/>
            <a:ext cx="777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Line 15">
            <a:extLst>
              <a:ext uri="{FF2B5EF4-FFF2-40B4-BE49-F238E27FC236}">
                <a16:creationId xmlns:a16="http://schemas.microsoft.com/office/drawing/2014/main" id="{D0C6853A-5715-4F3C-BAD9-AE111D331153}"/>
              </a:ext>
            </a:extLst>
          </p:cNvPr>
          <p:cNvSpPr>
            <a:spLocks noChangeShapeType="1"/>
          </p:cNvSpPr>
          <p:nvPr/>
        </p:nvSpPr>
        <p:spPr bwMode="auto">
          <a:xfrm>
            <a:off x="3783320" y="3319743"/>
            <a:ext cx="777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16">
            <a:extLst>
              <a:ext uri="{FF2B5EF4-FFF2-40B4-BE49-F238E27FC236}">
                <a16:creationId xmlns:a16="http://schemas.microsoft.com/office/drawing/2014/main" id="{67669393-68C2-4BD2-82C1-993FEE9C042D}"/>
              </a:ext>
            </a:extLst>
          </p:cNvPr>
          <p:cNvSpPr>
            <a:spLocks noChangeShapeType="1"/>
          </p:cNvSpPr>
          <p:nvPr/>
        </p:nvSpPr>
        <p:spPr bwMode="auto">
          <a:xfrm>
            <a:off x="3783320" y="2702205"/>
            <a:ext cx="777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17">
            <a:extLst>
              <a:ext uri="{FF2B5EF4-FFF2-40B4-BE49-F238E27FC236}">
                <a16:creationId xmlns:a16="http://schemas.microsoft.com/office/drawing/2014/main" id="{E80B3D9D-8E41-4D0D-B735-7BCD0A661896}"/>
              </a:ext>
            </a:extLst>
          </p:cNvPr>
          <p:cNvSpPr>
            <a:spLocks noChangeShapeType="1"/>
          </p:cNvSpPr>
          <p:nvPr/>
        </p:nvSpPr>
        <p:spPr bwMode="auto">
          <a:xfrm>
            <a:off x="3783320" y="2084668"/>
            <a:ext cx="777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Line 18">
            <a:extLst>
              <a:ext uri="{FF2B5EF4-FFF2-40B4-BE49-F238E27FC236}">
                <a16:creationId xmlns:a16="http://schemas.microsoft.com/office/drawing/2014/main" id="{4C91C647-AFEE-485F-B26A-DE53FC3CF5F1}"/>
              </a:ext>
            </a:extLst>
          </p:cNvPr>
          <p:cNvSpPr>
            <a:spLocks noChangeShapeType="1"/>
          </p:cNvSpPr>
          <p:nvPr/>
        </p:nvSpPr>
        <p:spPr bwMode="auto">
          <a:xfrm>
            <a:off x="3783320" y="1465543"/>
            <a:ext cx="777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9">
            <a:extLst>
              <a:ext uri="{FF2B5EF4-FFF2-40B4-BE49-F238E27FC236}">
                <a16:creationId xmlns:a16="http://schemas.microsoft.com/office/drawing/2014/main" id="{8D84586D-165A-4A19-964B-56A97C1023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00745" y="4454805"/>
            <a:ext cx="2308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%</a:t>
            </a:r>
            <a:endParaRPr kumimoji="0" lang="ja-JP" altLang="ja-JP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20">
            <a:extLst>
              <a:ext uri="{FF2B5EF4-FFF2-40B4-BE49-F238E27FC236}">
                <a16:creationId xmlns:a16="http://schemas.microsoft.com/office/drawing/2014/main" id="{1DD6303F-132F-4355-BB2F-1BFAD0A8DF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0257" y="3822980"/>
            <a:ext cx="30777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%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21">
            <a:extLst>
              <a:ext uri="{FF2B5EF4-FFF2-40B4-BE49-F238E27FC236}">
                <a16:creationId xmlns:a16="http://schemas.microsoft.com/office/drawing/2014/main" id="{6287E40E-9456-4E46-806B-C31C218F0A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0257" y="3205443"/>
            <a:ext cx="30777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40%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22">
            <a:extLst>
              <a:ext uri="{FF2B5EF4-FFF2-40B4-BE49-F238E27FC236}">
                <a16:creationId xmlns:a16="http://schemas.microsoft.com/office/drawing/2014/main" id="{AD4CA3FB-5BCD-4481-A483-CB93609F5B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0257" y="2586318"/>
            <a:ext cx="30777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60%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23">
            <a:extLst>
              <a:ext uri="{FF2B5EF4-FFF2-40B4-BE49-F238E27FC236}">
                <a16:creationId xmlns:a16="http://schemas.microsoft.com/office/drawing/2014/main" id="{EE6AC3F2-623F-4113-9B68-527D3B9C2E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0257" y="1968780"/>
            <a:ext cx="30777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80%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24">
            <a:extLst>
              <a:ext uri="{FF2B5EF4-FFF2-40B4-BE49-F238E27FC236}">
                <a16:creationId xmlns:a16="http://schemas.microsoft.com/office/drawing/2014/main" id="{EC745D30-AA6E-4BC1-8F89-284BDF1833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19770" y="1351243"/>
            <a:ext cx="38472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%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29">
            <a:extLst>
              <a:ext uri="{FF2B5EF4-FFF2-40B4-BE49-F238E27FC236}">
                <a16:creationId xmlns:a16="http://schemas.microsoft.com/office/drawing/2014/main" id="{CEC25CD1-2FCD-4A26-8E51-F29C051768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61107" y="1465543"/>
            <a:ext cx="4578350" cy="3090863"/>
          </a:xfrm>
          <a:prstGeom prst="rect">
            <a:avLst/>
          </a:prstGeom>
          <a:noFill/>
          <a:ln w="12700" cap="sq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" name="Line 31">
            <a:extLst>
              <a:ext uri="{FF2B5EF4-FFF2-40B4-BE49-F238E27FC236}">
                <a16:creationId xmlns:a16="http://schemas.microsoft.com/office/drawing/2014/main" id="{B7BD29FC-66B6-45D9-90F4-D51C1CD79767}"/>
              </a:ext>
            </a:extLst>
          </p:cNvPr>
          <p:cNvSpPr>
            <a:spLocks noChangeShapeType="1"/>
          </p:cNvSpPr>
          <p:nvPr/>
        </p:nvSpPr>
        <p:spPr bwMode="auto">
          <a:xfrm>
            <a:off x="4375457" y="4556405"/>
            <a:ext cx="0" cy="3810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Line 32">
            <a:extLst>
              <a:ext uri="{FF2B5EF4-FFF2-40B4-BE49-F238E27FC236}">
                <a16:creationId xmlns:a16="http://schemas.microsoft.com/office/drawing/2014/main" id="{DF02F6FA-593F-4332-9EB9-E5D6B29FA2DE}"/>
              </a:ext>
            </a:extLst>
          </p:cNvPr>
          <p:cNvSpPr>
            <a:spLocks noChangeShapeType="1"/>
          </p:cNvSpPr>
          <p:nvPr/>
        </p:nvSpPr>
        <p:spPr bwMode="auto">
          <a:xfrm>
            <a:off x="5391457" y="4556405"/>
            <a:ext cx="0" cy="3810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Line 33">
            <a:extLst>
              <a:ext uri="{FF2B5EF4-FFF2-40B4-BE49-F238E27FC236}">
                <a16:creationId xmlns:a16="http://schemas.microsoft.com/office/drawing/2014/main" id="{12C1CF44-21A3-40CF-B735-E1EFA44E2EAD}"/>
              </a:ext>
            </a:extLst>
          </p:cNvPr>
          <p:cNvSpPr>
            <a:spLocks noChangeShapeType="1"/>
          </p:cNvSpPr>
          <p:nvPr/>
        </p:nvSpPr>
        <p:spPr bwMode="auto">
          <a:xfrm>
            <a:off x="6407457" y="4556405"/>
            <a:ext cx="0" cy="3810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Line 34">
            <a:extLst>
              <a:ext uri="{FF2B5EF4-FFF2-40B4-BE49-F238E27FC236}">
                <a16:creationId xmlns:a16="http://schemas.microsoft.com/office/drawing/2014/main" id="{3D58C41E-434C-4170-8378-DCFB62E47AB6}"/>
              </a:ext>
            </a:extLst>
          </p:cNvPr>
          <p:cNvSpPr>
            <a:spLocks noChangeShapeType="1"/>
          </p:cNvSpPr>
          <p:nvPr/>
        </p:nvSpPr>
        <p:spPr bwMode="auto">
          <a:xfrm>
            <a:off x="7423457" y="4556405"/>
            <a:ext cx="0" cy="3810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Line 35">
            <a:extLst>
              <a:ext uri="{FF2B5EF4-FFF2-40B4-BE49-F238E27FC236}">
                <a16:creationId xmlns:a16="http://schemas.microsoft.com/office/drawing/2014/main" id="{65402D5E-EAC2-4EA8-B76F-30079F75ED51}"/>
              </a:ext>
            </a:extLst>
          </p:cNvPr>
          <p:cNvSpPr>
            <a:spLocks noChangeShapeType="1"/>
          </p:cNvSpPr>
          <p:nvPr/>
        </p:nvSpPr>
        <p:spPr bwMode="auto">
          <a:xfrm>
            <a:off x="8439457" y="4556405"/>
            <a:ext cx="0" cy="3810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Line 36">
            <a:extLst>
              <a:ext uri="{FF2B5EF4-FFF2-40B4-BE49-F238E27FC236}">
                <a16:creationId xmlns:a16="http://schemas.microsoft.com/office/drawing/2014/main" id="{C721FDF7-2AFC-432F-9848-E17EBBB83473}"/>
              </a:ext>
            </a:extLst>
          </p:cNvPr>
          <p:cNvSpPr>
            <a:spLocks noChangeShapeType="1"/>
          </p:cNvSpPr>
          <p:nvPr/>
        </p:nvSpPr>
        <p:spPr bwMode="auto">
          <a:xfrm>
            <a:off x="3861107" y="4556405"/>
            <a:ext cx="0" cy="77788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Line 37">
            <a:extLst>
              <a:ext uri="{FF2B5EF4-FFF2-40B4-BE49-F238E27FC236}">
                <a16:creationId xmlns:a16="http://schemas.microsoft.com/office/drawing/2014/main" id="{C7488145-9B17-46FC-912A-305A8C7EDB6D}"/>
              </a:ext>
            </a:extLst>
          </p:cNvPr>
          <p:cNvSpPr>
            <a:spLocks noChangeShapeType="1"/>
          </p:cNvSpPr>
          <p:nvPr/>
        </p:nvSpPr>
        <p:spPr bwMode="auto">
          <a:xfrm>
            <a:off x="4877107" y="4556405"/>
            <a:ext cx="0" cy="77788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Line 38">
            <a:extLst>
              <a:ext uri="{FF2B5EF4-FFF2-40B4-BE49-F238E27FC236}">
                <a16:creationId xmlns:a16="http://schemas.microsoft.com/office/drawing/2014/main" id="{CCF160F2-409A-4A2D-893F-6DDBE0980456}"/>
              </a:ext>
            </a:extLst>
          </p:cNvPr>
          <p:cNvSpPr>
            <a:spLocks noChangeShapeType="1"/>
          </p:cNvSpPr>
          <p:nvPr/>
        </p:nvSpPr>
        <p:spPr bwMode="auto">
          <a:xfrm>
            <a:off x="5893107" y="4556405"/>
            <a:ext cx="0" cy="77788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Line 39">
            <a:extLst>
              <a:ext uri="{FF2B5EF4-FFF2-40B4-BE49-F238E27FC236}">
                <a16:creationId xmlns:a16="http://schemas.microsoft.com/office/drawing/2014/main" id="{D23F2135-BAF1-4C64-BEE6-955E0F81C503}"/>
              </a:ext>
            </a:extLst>
          </p:cNvPr>
          <p:cNvSpPr>
            <a:spLocks noChangeShapeType="1"/>
          </p:cNvSpPr>
          <p:nvPr/>
        </p:nvSpPr>
        <p:spPr bwMode="auto">
          <a:xfrm>
            <a:off x="6909107" y="4556405"/>
            <a:ext cx="0" cy="77788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Line 40">
            <a:extLst>
              <a:ext uri="{FF2B5EF4-FFF2-40B4-BE49-F238E27FC236}">
                <a16:creationId xmlns:a16="http://schemas.microsoft.com/office/drawing/2014/main" id="{B26D3835-13FC-49FB-B334-A81AB9A37B75}"/>
              </a:ext>
            </a:extLst>
          </p:cNvPr>
          <p:cNvSpPr>
            <a:spLocks noChangeShapeType="1"/>
          </p:cNvSpPr>
          <p:nvPr/>
        </p:nvSpPr>
        <p:spPr bwMode="auto">
          <a:xfrm>
            <a:off x="7925107" y="4556405"/>
            <a:ext cx="0" cy="77788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ectangle 41">
            <a:extLst>
              <a:ext uri="{FF2B5EF4-FFF2-40B4-BE49-F238E27FC236}">
                <a16:creationId xmlns:a16="http://schemas.microsoft.com/office/drawing/2014/main" id="{12211221-D6F5-4A2F-83DB-58A8AF2122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08720" y="4634193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tangle 42">
            <a:extLst>
              <a:ext uri="{FF2B5EF4-FFF2-40B4-BE49-F238E27FC236}">
                <a16:creationId xmlns:a16="http://schemas.microsoft.com/office/drawing/2014/main" id="{511D88B9-1107-4EF0-8710-6CEB239BDE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86620" y="4634193"/>
            <a:ext cx="15388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43">
            <a:extLst>
              <a:ext uri="{FF2B5EF4-FFF2-40B4-BE49-F238E27FC236}">
                <a16:creationId xmlns:a16="http://schemas.microsoft.com/office/drawing/2014/main" id="{4AD26F0E-2E87-4D85-9BF9-99891D2C22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51820" y="4634193"/>
            <a:ext cx="2308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44">
            <a:extLst>
              <a:ext uri="{FF2B5EF4-FFF2-40B4-BE49-F238E27FC236}">
                <a16:creationId xmlns:a16="http://schemas.microsoft.com/office/drawing/2014/main" id="{D609F2A1-BD7A-45C4-8CD3-AE93403C24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67820" y="4634193"/>
            <a:ext cx="2308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50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ectangle 45">
            <a:extLst>
              <a:ext uri="{FF2B5EF4-FFF2-40B4-BE49-F238E27FC236}">
                <a16:creationId xmlns:a16="http://schemas.microsoft.com/office/drawing/2014/main" id="{62D02F99-9B20-45F1-A97B-8192913313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83820" y="4634193"/>
            <a:ext cx="2308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0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99">
            <a:extLst>
              <a:ext uri="{FF2B5EF4-FFF2-40B4-BE49-F238E27FC236}">
                <a16:creationId xmlns:a16="http://schemas.microsoft.com/office/drawing/2014/main" id="{2268E235-7BFC-4BA8-9A68-68595A041B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44737" y="1775105"/>
            <a:ext cx="1221809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51</a:t>
            </a:r>
            <a:endParaRPr kumimoji="1" lang="en-US" altLang="ja-JP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1A1DD391-8A9A-4100-8B5D-622D573BC8D2}"/>
              </a:ext>
            </a:extLst>
          </p:cNvPr>
          <p:cNvGrpSpPr/>
          <p:nvPr/>
        </p:nvGrpSpPr>
        <p:grpSpPr>
          <a:xfrm>
            <a:off x="8796783" y="1615422"/>
            <a:ext cx="2997284" cy="525394"/>
            <a:chOff x="7204076" y="995392"/>
            <a:chExt cx="2446950" cy="525394"/>
          </a:xfrm>
        </p:grpSpPr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83FCC494-E00C-4F52-92E5-7A8355958FC3}"/>
                </a:ext>
              </a:extLst>
            </p:cNvPr>
            <p:cNvCxnSpPr>
              <a:cxnSpLocks/>
            </p:cNvCxnSpPr>
            <p:nvPr/>
          </p:nvCxnSpPr>
          <p:spPr>
            <a:xfrm>
              <a:off x="7204076" y="1133891"/>
              <a:ext cx="490537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C9726E00-8843-4847-832B-A2A76A56F9E8}"/>
                </a:ext>
              </a:extLst>
            </p:cNvPr>
            <p:cNvCxnSpPr>
              <a:cxnSpLocks/>
            </p:cNvCxnSpPr>
            <p:nvPr/>
          </p:nvCxnSpPr>
          <p:spPr>
            <a:xfrm>
              <a:off x="7204076" y="1382286"/>
              <a:ext cx="490537" cy="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F338908D-7C67-4316-B4CC-EDFB508CBC61}"/>
                </a:ext>
              </a:extLst>
            </p:cNvPr>
            <p:cNvSpPr txBox="1"/>
            <p:nvPr/>
          </p:nvSpPr>
          <p:spPr>
            <a:xfrm>
              <a:off x="7754923" y="1243787"/>
              <a:ext cx="18961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LC intermediate-stage (n=47)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1701D57A-B245-4917-8E0E-E52B04C5F574}"/>
                </a:ext>
              </a:extLst>
            </p:cNvPr>
            <p:cNvSpPr txBox="1"/>
            <p:nvPr/>
          </p:nvSpPr>
          <p:spPr>
            <a:xfrm>
              <a:off x="7751202" y="995392"/>
              <a:ext cx="18971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LC early-stage (n=53)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85CFDAFF-D3FC-4F1B-BE27-2E8958F31DEC}"/>
              </a:ext>
            </a:extLst>
          </p:cNvPr>
          <p:cNvSpPr txBox="1"/>
          <p:nvPr/>
        </p:nvSpPr>
        <p:spPr>
          <a:xfrm rot="10800000">
            <a:off x="2609890" y="2140816"/>
            <a:ext cx="369332" cy="190372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 free survival rate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0691D47B-925C-424F-BE2B-B443AEC1DBD3}"/>
              </a:ext>
            </a:extLst>
          </p:cNvPr>
          <p:cNvSpPr txBox="1"/>
          <p:nvPr/>
        </p:nvSpPr>
        <p:spPr>
          <a:xfrm>
            <a:off x="5968505" y="4758146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ths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EFB1320E-C192-4FB6-ACD3-F2349160F4BF}"/>
              </a:ext>
            </a:extLst>
          </p:cNvPr>
          <p:cNvSpPr txBox="1"/>
          <p:nvPr/>
        </p:nvSpPr>
        <p:spPr>
          <a:xfrm>
            <a:off x="1160543" y="350404"/>
            <a:ext cx="99618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ifference in progression-free survival rates based on the BCLC staging system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455DCCBF-F16B-4F07-8EF0-20E84B88668A}"/>
              </a:ext>
            </a:extLst>
          </p:cNvPr>
          <p:cNvSpPr txBox="1"/>
          <p:nvPr/>
        </p:nvSpPr>
        <p:spPr>
          <a:xfrm>
            <a:off x="3875044" y="4961069"/>
            <a:ext cx="10935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at risk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0" name="表 49">
            <a:extLst>
              <a:ext uri="{FF2B5EF4-FFF2-40B4-BE49-F238E27FC236}">
                <a16:creationId xmlns:a16="http://schemas.microsoft.com/office/drawing/2014/main" id="{C5AB631F-E71E-4470-B514-80B10AE3CF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6524198"/>
              </p:ext>
            </p:extLst>
          </p:nvPr>
        </p:nvGraphicFramePr>
        <p:xfrm>
          <a:off x="3852287" y="5230808"/>
          <a:ext cx="4578349" cy="53149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32383">
                  <a:extLst>
                    <a:ext uri="{9D8B030D-6E8A-4147-A177-3AD203B41FA5}">
                      <a16:colId xmlns:a16="http://schemas.microsoft.com/office/drawing/2014/main" val="4023799681"/>
                    </a:ext>
                  </a:extLst>
                </a:gridCol>
                <a:gridCol w="507661">
                  <a:extLst>
                    <a:ext uri="{9D8B030D-6E8A-4147-A177-3AD203B41FA5}">
                      <a16:colId xmlns:a16="http://schemas.microsoft.com/office/drawing/2014/main" val="2796062570"/>
                    </a:ext>
                  </a:extLst>
                </a:gridCol>
                <a:gridCol w="507661">
                  <a:extLst>
                    <a:ext uri="{9D8B030D-6E8A-4147-A177-3AD203B41FA5}">
                      <a16:colId xmlns:a16="http://schemas.microsoft.com/office/drawing/2014/main" val="3686338354"/>
                    </a:ext>
                  </a:extLst>
                </a:gridCol>
                <a:gridCol w="507661">
                  <a:extLst>
                    <a:ext uri="{9D8B030D-6E8A-4147-A177-3AD203B41FA5}">
                      <a16:colId xmlns:a16="http://schemas.microsoft.com/office/drawing/2014/main" val="4072055641"/>
                    </a:ext>
                  </a:extLst>
                </a:gridCol>
                <a:gridCol w="507661">
                  <a:extLst>
                    <a:ext uri="{9D8B030D-6E8A-4147-A177-3AD203B41FA5}">
                      <a16:colId xmlns:a16="http://schemas.microsoft.com/office/drawing/2014/main" val="465771520"/>
                    </a:ext>
                  </a:extLst>
                </a:gridCol>
                <a:gridCol w="507661">
                  <a:extLst>
                    <a:ext uri="{9D8B030D-6E8A-4147-A177-3AD203B41FA5}">
                      <a16:colId xmlns:a16="http://schemas.microsoft.com/office/drawing/2014/main" val="4126565409"/>
                    </a:ext>
                  </a:extLst>
                </a:gridCol>
                <a:gridCol w="507661">
                  <a:extLst>
                    <a:ext uri="{9D8B030D-6E8A-4147-A177-3AD203B41FA5}">
                      <a16:colId xmlns:a16="http://schemas.microsoft.com/office/drawing/2014/main" val="411648977"/>
                    </a:ext>
                  </a:extLst>
                </a:gridCol>
              </a:tblGrid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6097120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Early-stag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3071874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Intermediate-stag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8821480"/>
                  </a:ext>
                </a:extLst>
              </a:tr>
            </a:tbl>
          </a:graphicData>
        </a:graphic>
      </p:graphicFrame>
      <p:sp>
        <p:nvSpPr>
          <p:cNvPr id="2" name="Freeform 27">
            <a:extLst>
              <a:ext uri="{FF2B5EF4-FFF2-40B4-BE49-F238E27FC236}">
                <a16:creationId xmlns:a16="http://schemas.microsoft.com/office/drawing/2014/main" id="{9E768233-38B8-E7D0-BF49-64744567BDC7}"/>
              </a:ext>
            </a:extLst>
          </p:cNvPr>
          <p:cNvSpPr>
            <a:spLocks/>
          </p:cNvSpPr>
          <p:nvPr/>
        </p:nvSpPr>
        <p:spPr bwMode="auto">
          <a:xfrm>
            <a:off x="3869795" y="1482192"/>
            <a:ext cx="4472514" cy="2857926"/>
          </a:xfrm>
          <a:custGeom>
            <a:avLst/>
            <a:gdLst>
              <a:gd name="T0" fmla="*/ 0 w 2844"/>
              <a:gd name="T1" fmla="*/ 0 h 1821"/>
              <a:gd name="T2" fmla="*/ 14 w 2844"/>
              <a:gd name="T3" fmla="*/ 0 h 1821"/>
              <a:gd name="T4" fmla="*/ 14 w 2844"/>
              <a:gd name="T5" fmla="*/ 43 h 1821"/>
              <a:gd name="T6" fmla="*/ 27 w 2844"/>
              <a:gd name="T7" fmla="*/ 43 h 1821"/>
              <a:gd name="T8" fmla="*/ 27 w 2844"/>
              <a:gd name="T9" fmla="*/ 128 h 1821"/>
              <a:gd name="T10" fmla="*/ 40 w 2844"/>
              <a:gd name="T11" fmla="*/ 128 h 1821"/>
              <a:gd name="T12" fmla="*/ 40 w 2844"/>
              <a:gd name="T13" fmla="*/ 212 h 1821"/>
              <a:gd name="T14" fmla="*/ 53 w 2844"/>
              <a:gd name="T15" fmla="*/ 212 h 1821"/>
              <a:gd name="T16" fmla="*/ 53 w 2844"/>
              <a:gd name="T17" fmla="*/ 386 h 1821"/>
              <a:gd name="T18" fmla="*/ 66 w 2844"/>
              <a:gd name="T19" fmla="*/ 386 h 1821"/>
              <a:gd name="T20" fmla="*/ 66 w 2844"/>
              <a:gd name="T21" fmla="*/ 646 h 1821"/>
              <a:gd name="T22" fmla="*/ 79 w 2844"/>
              <a:gd name="T23" fmla="*/ 646 h 1821"/>
              <a:gd name="T24" fmla="*/ 79 w 2844"/>
              <a:gd name="T25" fmla="*/ 689 h 1821"/>
              <a:gd name="T26" fmla="*/ 92 w 2844"/>
              <a:gd name="T27" fmla="*/ 689 h 1821"/>
              <a:gd name="T28" fmla="*/ 92 w 2844"/>
              <a:gd name="T29" fmla="*/ 776 h 1821"/>
              <a:gd name="T30" fmla="*/ 105 w 2844"/>
              <a:gd name="T31" fmla="*/ 776 h 1821"/>
              <a:gd name="T32" fmla="*/ 105 w 2844"/>
              <a:gd name="T33" fmla="*/ 906 h 1821"/>
              <a:gd name="T34" fmla="*/ 118 w 2844"/>
              <a:gd name="T35" fmla="*/ 906 h 1821"/>
              <a:gd name="T36" fmla="*/ 118 w 2844"/>
              <a:gd name="T37" fmla="*/ 951 h 1821"/>
              <a:gd name="T38" fmla="*/ 132 w 2844"/>
              <a:gd name="T39" fmla="*/ 951 h 1821"/>
              <a:gd name="T40" fmla="*/ 132 w 2844"/>
              <a:gd name="T41" fmla="*/ 996 h 1821"/>
              <a:gd name="T42" fmla="*/ 145 w 2844"/>
              <a:gd name="T43" fmla="*/ 996 h 1821"/>
              <a:gd name="T44" fmla="*/ 145 w 2844"/>
              <a:gd name="T45" fmla="*/ 1132 h 1821"/>
              <a:gd name="T46" fmla="*/ 158 w 2844"/>
              <a:gd name="T47" fmla="*/ 1132 h 1821"/>
              <a:gd name="T48" fmla="*/ 158 w 2844"/>
              <a:gd name="T49" fmla="*/ 1313 h 1821"/>
              <a:gd name="T50" fmla="*/ 184 w 2844"/>
              <a:gd name="T51" fmla="*/ 1313 h 1821"/>
              <a:gd name="T52" fmla="*/ 184 w 2844"/>
              <a:gd name="T53" fmla="*/ 1358 h 1821"/>
              <a:gd name="T54" fmla="*/ 197 w 2844"/>
              <a:gd name="T55" fmla="*/ 1358 h 1821"/>
              <a:gd name="T56" fmla="*/ 197 w 2844"/>
              <a:gd name="T57" fmla="*/ 1403 h 1821"/>
              <a:gd name="T58" fmla="*/ 236 w 2844"/>
              <a:gd name="T59" fmla="*/ 1403 h 1821"/>
              <a:gd name="T60" fmla="*/ 236 w 2844"/>
              <a:gd name="T61" fmla="*/ 1493 h 1821"/>
              <a:gd name="T62" fmla="*/ 249 w 2844"/>
              <a:gd name="T63" fmla="*/ 1493 h 1821"/>
              <a:gd name="T64" fmla="*/ 249 w 2844"/>
              <a:gd name="T65" fmla="*/ 1539 h 1821"/>
              <a:gd name="T66" fmla="*/ 263 w 2844"/>
              <a:gd name="T67" fmla="*/ 1539 h 1821"/>
              <a:gd name="T68" fmla="*/ 263 w 2844"/>
              <a:gd name="T69" fmla="*/ 1584 h 1821"/>
              <a:gd name="T70" fmla="*/ 276 w 2844"/>
              <a:gd name="T71" fmla="*/ 1584 h 1821"/>
              <a:gd name="T72" fmla="*/ 276 w 2844"/>
              <a:gd name="T73" fmla="*/ 1629 h 1821"/>
              <a:gd name="T74" fmla="*/ 302 w 2844"/>
              <a:gd name="T75" fmla="*/ 1629 h 1821"/>
              <a:gd name="T76" fmla="*/ 302 w 2844"/>
              <a:gd name="T77" fmla="*/ 1674 h 1821"/>
              <a:gd name="T78" fmla="*/ 381 w 2844"/>
              <a:gd name="T79" fmla="*/ 1674 h 1821"/>
              <a:gd name="T80" fmla="*/ 381 w 2844"/>
              <a:gd name="T81" fmla="*/ 1765 h 1821"/>
              <a:gd name="T82" fmla="*/ 630 w 2844"/>
              <a:gd name="T83" fmla="*/ 1765 h 1821"/>
              <a:gd name="T84" fmla="*/ 734 w 2844"/>
              <a:gd name="T85" fmla="*/ 1765 h 1821"/>
              <a:gd name="T86" fmla="*/ 734 w 2844"/>
              <a:gd name="T87" fmla="*/ 1821 h 1821"/>
              <a:gd name="T88" fmla="*/ 1219 w 2844"/>
              <a:gd name="T89" fmla="*/ 1821 h 1821"/>
              <a:gd name="T90" fmla="*/ 1521 w 2844"/>
              <a:gd name="T91" fmla="*/ 1821 h 1821"/>
              <a:gd name="T92" fmla="*/ 2844 w 2844"/>
              <a:gd name="T93" fmla="*/ 1821 h 18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</a:cxnLst>
            <a:rect l="0" t="0" r="r" b="b"/>
            <a:pathLst>
              <a:path w="2844" h="1821">
                <a:moveTo>
                  <a:pt x="0" y="0"/>
                </a:moveTo>
                <a:lnTo>
                  <a:pt x="14" y="0"/>
                </a:lnTo>
                <a:lnTo>
                  <a:pt x="14" y="43"/>
                </a:lnTo>
                <a:lnTo>
                  <a:pt x="27" y="43"/>
                </a:lnTo>
                <a:lnTo>
                  <a:pt x="27" y="128"/>
                </a:lnTo>
                <a:lnTo>
                  <a:pt x="40" y="128"/>
                </a:lnTo>
                <a:lnTo>
                  <a:pt x="40" y="212"/>
                </a:lnTo>
                <a:lnTo>
                  <a:pt x="53" y="212"/>
                </a:lnTo>
                <a:lnTo>
                  <a:pt x="53" y="386"/>
                </a:lnTo>
                <a:lnTo>
                  <a:pt x="66" y="386"/>
                </a:lnTo>
                <a:lnTo>
                  <a:pt x="66" y="646"/>
                </a:lnTo>
                <a:lnTo>
                  <a:pt x="79" y="646"/>
                </a:lnTo>
                <a:lnTo>
                  <a:pt x="79" y="689"/>
                </a:lnTo>
                <a:lnTo>
                  <a:pt x="92" y="689"/>
                </a:lnTo>
                <a:lnTo>
                  <a:pt x="92" y="776"/>
                </a:lnTo>
                <a:lnTo>
                  <a:pt x="105" y="776"/>
                </a:lnTo>
                <a:lnTo>
                  <a:pt x="105" y="906"/>
                </a:lnTo>
                <a:lnTo>
                  <a:pt x="118" y="906"/>
                </a:lnTo>
                <a:lnTo>
                  <a:pt x="118" y="951"/>
                </a:lnTo>
                <a:lnTo>
                  <a:pt x="132" y="951"/>
                </a:lnTo>
                <a:lnTo>
                  <a:pt x="132" y="996"/>
                </a:lnTo>
                <a:lnTo>
                  <a:pt x="145" y="996"/>
                </a:lnTo>
                <a:lnTo>
                  <a:pt x="145" y="1132"/>
                </a:lnTo>
                <a:lnTo>
                  <a:pt x="158" y="1132"/>
                </a:lnTo>
                <a:lnTo>
                  <a:pt x="158" y="1313"/>
                </a:lnTo>
                <a:lnTo>
                  <a:pt x="184" y="1313"/>
                </a:lnTo>
                <a:lnTo>
                  <a:pt x="184" y="1358"/>
                </a:lnTo>
                <a:lnTo>
                  <a:pt x="197" y="1358"/>
                </a:lnTo>
                <a:lnTo>
                  <a:pt x="197" y="1403"/>
                </a:lnTo>
                <a:lnTo>
                  <a:pt x="236" y="1403"/>
                </a:lnTo>
                <a:lnTo>
                  <a:pt x="236" y="1493"/>
                </a:lnTo>
                <a:lnTo>
                  <a:pt x="249" y="1493"/>
                </a:lnTo>
                <a:lnTo>
                  <a:pt x="249" y="1539"/>
                </a:lnTo>
                <a:lnTo>
                  <a:pt x="263" y="1539"/>
                </a:lnTo>
                <a:lnTo>
                  <a:pt x="263" y="1584"/>
                </a:lnTo>
                <a:lnTo>
                  <a:pt x="276" y="1584"/>
                </a:lnTo>
                <a:lnTo>
                  <a:pt x="276" y="1629"/>
                </a:lnTo>
                <a:lnTo>
                  <a:pt x="302" y="1629"/>
                </a:lnTo>
                <a:lnTo>
                  <a:pt x="302" y="1674"/>
                </a:lnTo>
                <a:lnTo>
                  <a:pt x="381" y="1674"/>
                </a:lnTo>
                <a:lnTo>
                  <a:pt x="381" y="1765"/>
                </a:lnTo>
                <a:lnTo>
                  <a:pt x="630" y="1765"/>
                </a:lnTo>
                <a:lnTo>
                  <a:pt x="734" y="1765"/>
                </a:lnTo>
                <a:lnTo>
                  <a:pt x="734" y="1821"/>
                </a:lnTo>
                <a:lnTo>
                  <a:pt x="1219" y="1821"/>
                </a:lnTo>
                <a:lnTo>
                  <a:pt x="1521" y="1821"/>
                </a:lnTo>
                <a:lnTo>
                  <a:pt x="2844" y="1821"/>
                </a:lnTo>
              </a:path>
            </a:pathLst>
          </a:custGeom>
          <a:noFill/>
          <a:ln w="26988" cap="flat">
            <a:solidFill>
              <a:srgbClr val="4270DD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" name="Freeform 26">
            <a:extLst>
              <a:ext uri="{FF2B5EF4-FFF2-40B4-BE49-F238E27FC236}">
                <a16:creationId xmlns:a16="http://schemas.microsoft.com/office/drawing/2014/main" id="{9A027E53-7CDD-405C-0153-228CAE57D910}"/>
              </a:ext>
            </a:extLst>
          </p:cNvPr>
          <p:cNvSpPr>
            <a:spLocks/>
          </p:cNvSpPr>
          <p:nvPr/>
        </p:nvSpPr>
        <p:spPr bwMode="auto">
          <a:xfrm>
            <a:off x="3869795" y="1473730"/>
            <a:ext cx="3978806" cy="2570814"/>
          </a:xfrm>
          <a:custGeom>
            <a:avLst/>
            <a:gdLst>
              <a:gd name="T0" fmla="*/ 0 w 2543"/>
              <a:gd name="T1" fmla="*/ 0 h 1655"/>
              <a:gd name="T2" fmla="*/ 14 w 2543"/>
              <a:gd name="T3" fmla="*/ 0 h 1655"/>
              <a:gd name="T4" fmla="*/ 14 w 2543"/>
              <a:gd name="T5" fmla="*/ 75 h 1655"/>
              <a:gd name="T6" fmla="*/ 27 w 2543"/>
              <a:gd name="T7" fmla="*/ 75 h 1655"/>
              <a:gd name="T8" fmla="*/ 27 w 2543"/>
              <a:gd name="T9" fmla="*/ 150 h 1655"/>
              <a:gd name="T10" fmla="*/ 40 w 2543"/>
              <a:gd name="T11" fmla="*/ 150 h 1655"/>
              <a:gd name="T12" fmla="*/ 40 w 2543"/>
              <a:gd name="T13" fmla="*/ 226 h 1655"/>
              <a:gd name="T14" fmla="*/ 53 w 2543"/>
              <a:gd name="T15" fmla="*/ 226 h 1655"/>
              <a:gd name="T16" fmla="*/ 53 w 2543"/>
              <a:gd name="T17" fmla="*/ 263 h 1655"/>
              <a:gd name="T18" fmla="*/ 79 w 2543"/>
              <a:gd name="T19" fmla="*/ 263 h 1655"/>
              <a:gd name="T20" fmla="*/ 79 w 2543"/>
              <a:gd name="T21" fmla="*/ 302 h 1655"/>
              <a:gd name="T22" fmla="*/ 92 w 2543"/>
              <a:gd name="T23" fmla="*/ 302 h 1655"/>
              <a:gd name="T24" fmla="*/ 92 w 2543"/>
              <a:gd name="T25" fmla="*/ 417 h 1655"/>
              <a:gd name="T26" fmla="*/ 105 w 2543"/>
              <a:gd name="T27" fmla="*/ 417 h 1655"/>
              <a:gd name="T28" fmla="*/ 105 w 2543"/>
              <a:gd name="T29" fmla="*/ 570 h 1655"/>
              <a:gd name="T30" fmla="*/ 118 w 2543"/>
              <a:gd name="T31" fmla="*/ 570 h 1655"/>
              <a:gd name="T32" fmla="*/ 118 w 2543"/>
              <a:gd name="T33" fmla="*/ 724 h 1655"/>
              <a:gd name="T34" fmla="*/ 132 w 2543"/>
              <a:gd name="T35" fmla="*/ 724 h 1655"/>
              <a:gd name="T36" fmla="*/ 132 w 2543"/>
              <a:gd name="T37" fmla="*/ 762 h 1655"/>
              <a:gd name="T38" fmla="*/ 145 w 2543"/>
              <a:gd name="T39" fmla="*/ 762 h 1655"/>
              <a:gd name="T40" fmla="*/ 145 w 2543"/>
              <a:gd name="T41" fmla="*/ 839 h 1655"/>
              <a:gd name="T42" fmla="*/ 158 w 2543"/>
              <a:gd name="T43" fmla="*/ 839 h 1655"/>
              <a:gd name="T44" fmla="*/ 158 w 2543"/>
              <a:gd name="T45" fmla="*/ 916 h 1655"/>
              <a:gd name="T46" fmla="*/ 171 w 2543"/>
              <a:gd name="T47" fmla="*/ 916 h 1655"/>
              <a:gd name="T48" fmla="*/ 171 w 2543"/>
              <a:gd name="T49" fmla="*/ 993 h 1655"/>
              <a:gd name="T50" fmla="*/ 184 w 2543"/>
              <a:gd name="T51" fmla="*/ 993 h 1655"/>
              <a:gd name="T52" fmla="*/ 184 w 2543"/>
              <a:gd name="T53" fmla="*/ 1108 h 1655"/>
              <a:gd name="T54" fmla="*/ 197 w 2543"/>
              <a:gd name="T55" fmla="*/ 1108 h 1655"/>
              <a:gd name="T56" fmla="*/ 197 w 2543"/>
              <a:gd name="T57" fmla="*/ 1184 h 1655"/>
              <a:gd name="T58" fmla="*/ 210 w 2543"/>
              <a:gd name="T59" fmla="*/ 1184 h 1655"/>
              <a:gd name="T60" fmla="*/ 210 w 2543"/>
              <a:gd name="T61" fmla="*/ 1223 h 1655"/>
              <a:gd name="T62" fmla="*/ 223 w 2543"/>
              <a:gd name="T63" fmla="*/ 1223 h 1655"/>
              <a:gd name="T64" fmla="*/ 223 w 2543"/>
              <a:gd name="T65" fmla="*/ 1261 h 1655"/>
              <a:gd name="T66" fmla="*/ 249 w 2543"/>
              <a:gd name="T67" fmla="*/ 1261 h 1655"/>
              <a:gd name="T68" fmla="*/ 249 w 2543"/>
              <a:gd name="T69" fmla="*/ 1299 h 1655"/>
              <a:gd name="T70" fmla="*/ 302 w 2543"/>
              <a:gd name="T71" fmla="*/ 1299 h 1655"/>
              <a:gd name="T72" fmla="*/ 315 w 2543"/>
              <a:gd name="T73" fmla="*/ 1299 h 1655"/>
              <a:gd name="T74" fmla="*/ 315 w 2543"/>
              <a:gd name="T75" fmla="*/ 1340 h 1655"/>
              <a:gd name="T76" fmla="*/ 381 w 2543"/>
              <a:gd name="T77" fmla="*/ 1340 h 1655"/>
              <a:gd name="T78" fmla="*/ 381 w 2543"/>
              <a:gd name="T79" fmla="*/ 1381 h 1655"/>
              <a:gd name="T80" fmla="*/ 394 w 2543"/>
              <a:gd name="T81" fmla="*/ 1381 h 1655"/>
              <a:gd name="T82" fmla="*/ 394 w 2543"/>
              <a:gd name="T83" fmla="*/ 1422 h 1655"/>
              <a:gd name="T84" fmla="*/ 420 w 2543"/>
              <a:gd name="T85" fmla="*/ 1422 h 1655"/>
              <a:gd name="T86" fmla="*/ 420 w 2543"/>
              <a:gd name="T87" fmla="*/ 1462 h 1655"/>
              <a:gd name="T88" fmla="*/ 459 w 2543"/>
              <a:gd name="T89" fmla="*/ 1462 h 1655"/>
              <a:gd name="T90" fmla="*/ 459 w 2543"/>
              <a:gd name="T91" fmla="*/ 1503 h 1655"/>
              <a:gd name="T92" fmla="*/ 472 w 2543"/>
              <a:gd name="T93" fmla="*/ 1503 h 1655"/>
              <a:gd name="T94" fmla="*/ 472 w 2543"/>
              <a:gd name="T95" fmla="*/ 1543 h 1655"/>
              <a:gd name="T96" fmla="*/ 682 w 2543"/>
              <a:gd name="T97" fmla="*/ 1543 h 1655"/>
              <a:gd name="T98" fmla="*/ 944 w 2543"/>
              <a:gd name="T99" fmla="*/ 1543 h 1655"/>
              <a:gd name="T100" fmla="*/ 1101 w 2543"/>
              <a:gd name="T101" fmla="*/ 1543 h 1655"/>
              <a:gd name="T102" fmla="*/ 1180 w 2543"/>
              <a:gd name="T103" fmla="*/ 1543 h 1655"/>
              <a:gd name="T104" fmla="*/ 1219 w 2543"/>
              <a:gd name="T105" fmla="*/ 1543 h 1655"/>
              <a:gd name="T106" fmla="*/ 1284 w 2543"/>
              <a:gd name="T107" fmla="*/ 1543 h 1655"/>
              <a:gd name="T108" fmla="*/ 1521 w 2543"/>
              <a:gd name="T109" fmla="*/ 1543 h 1655"/>
              <a:gd name="T110" fmla="*/ 1521 w 2543"/>
              <a:gd name="T111" fmla="*/ 1655 h 1655"/>
              <a:gd name="T112" fmla="*/ 1796 w 2543"/>
              <a:gd name="T113" fmla="*/ 1655 h 1655"/>
              <a:gd name="T114" fmla="*/ 2385 w 2543"/>
              <a:gd name="T115" fmla="*/ 1655 h 1655"/>
              <a:gd name="T116" fmla="*/ 2543 w 2543"/>
              <a:gd name="T117" fmla="*/ 1655 h 16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2543" h="1655">
                <a:moveTo>
                  <a:pt x="0" y="0"/>
                </a:moveTo>
                <a:lnTo>
                  <a:pt x="14" y="0"/>
                </a:lnTo>
                <a:lnTo>
                  <a:pt x="14" y="75"/>
                </a:lnTo>
                <a:lnTo>
                  <a:pt x="27" y="75"/>
                </a:lnTo>
                <a:lnTo>
                  <a:pt x="27" y="150"/>
                </a:lnTo>
                <a:lnTo>
                  <a:pt x="40" y="150"/>
                </a:lnTo>
                <a:lnTo>
                  <a:pt x="40" y="226"/>
                </a:lnTo>
                <a:lnTo>
                  <a:pt x="53" y="226"/>
                </a:lnTo>
                <a:lnTo>
                  <a:pt x="53" y="263"/>
                </a:lnTo>
                <a:lnTo>
                  <a:pt x="79" y="263"/>
                </a:lnTo>
                <a:lnTo>
                  <a:pt x="79" y="302"/>
                </a:lnTo>
                <a:lnTo>
                  <a:pt x="92" y="302"/>
                </a:lnTo>
                <a:lnTo>
                  <a:pt x="92" y="417"/>
                </a:lnTo>
                <a:lnTo>
                  <a:pt x="105" y="417"/>
                </a:lnTo>
                <a:lnTo>
                  <a:pt x="105" y="570"/>
                </a:lnTo>
                <a:lnTo>
                  <a:pt x="118" y="570"/>
                </a:lnTo>
                <a:lnTo>
                  <a:pt x="118" y="724"/>
                </a:lnTo>
                <a:lnTo>
                  <a:pt x="132" y="724"/>
                </a:lnTo>
                <a:lnTo>
                  <a:pt x="132" y="762"/>
                </a:lnTo>
                <a:lnTo>
                  <a:pt x="145" y="762"/>
                </a:lnTo>
                <a:lnTo>
                  <a:pt x="145" y="839"/>
                </a:lnTo>
                <a:lnTo>
                  <a:pt x="158" y="839"/>
                </a:lnTo>
                <a:lnTo>
                  <a:pt x="158" y="916"/>
                </a:lnTo>
                <a:lnTo>
                  <a:pt x="171" y="916"/>
                </a:lnTo>
                <a:lnTo>
                  <a:pt x="171" y="993"/>
                </a:lnTo>
                <a:lnTo>
                  <a:pt x="184" y="993"/>
                </a:lnTo>
                <a:lnTo>
                  <a:pt x="184" y="1108"/>
                </a:lnTo>
                <a:lnTo>
                  <a:pt x="197" y="1108"/>
                </a:lnTo>
                <a:lnTo>
                  <a:pt x="197" y="1184"/>
                </a:lnTo>
                <a:lnTo>
                  <a:pt x="210" y="1184"/>
                </a:lnTo>
                <a:lnTo>
                  <a:pt x="210" y="1223"/>
                </a:lnTo>
                <a:lnTo>
                  <a:pt x="223" y="1223"/>
                </a:lnTo>
                <a:lnTo>
                  <a:pt x="223" y="1261"/>
                </a:lnTo>
                <a:lnTo>
                  <a:pt x="249" y="1261"/>
                </a:lnTo>
                <a:lnTo>
                  <a:pt x="249" y="1299"/>
                </a:lnTo>
                <a:lnTo>
                  <a:pt x="302" y="1299"/>
                </a:lnTo>
                <a:lnTo>
                  <a:pt x="315" y="1299"/>
                </a:lnTo>
                <a:lnTo>
                  <a:pt x="315" y="1340"/>
                </a:lnTo>
                <a:lnTo>
                  <a:pt x="381" y="1340"/>
                </a:lnTo>
                <a:lnTo>
                  <a:pt x="381" y="1381"/>
                </a:lnTo>
                <a:lnTo>
                  <a:pt x="394" y="1381"/>
                </a:lnTo>
                <a:lnTo>
                  <a:pt x="394" y="1422"/>
                </a:lnTo>
                <a:lnTo>
                  <a:pt x="420" y="1422"/>
                </a:lnTo>
                <a:lnTo>
                  <a:pt x="420" y="1462"/>
                </a:lnTo>
                <a:lnTo>
                  <a:pt x="459" y="1462"/>
                </a:lnTo>
                <a:lnTo>
                  <a:pt x="459" y="1503"/>
                </a:lnTo>
                <a:lnTo>
                  <a:pt x="472" y="1503"/>
                </a:lnTo>
                <a:lnTo>
                  <a:pt x="472" y="1543"/>
                </a:lnTo>
                <a:lnTo>
                  <a:pt x="682" y="1543"/>
                </a:lnTo>
                <a:lnTo>
                  <a:pt x="944" y="1543"/>
                </a:lnTo>
                <a:lnTo>
                  <a:pt x="1101" y="1543"/>
                </a:lnTo>
                <a:lnTo>
                  <a:pt x="1180" y="1543"/>
                </a:lnTo>
                <a:lnTo>
                  <a:pt x="1219" y="1543"/>
                </a:lnTo>
                <a:lnTo>
                  <a:pt x="1284" y="1543"/>
                </a:lnTo>
                <a:lnTo>
                  <a:pt x="1521" y="1543"/>
                </a:lnTo>
                <a:lnTo>
                  <a:pt x="1521" y="1655"/>
                </a:lnTo>
                <a:lnTo>
                  <a:pt x="1796" y="1655"/>
                </a:lnTo>
                <a:lnTo>
                  <a:pt x="2385" y="1655"/>
                </a:lnTo>
                <a:lnTo>
                  <a:pt x="2543" y="1655"/>
                </a:lnTo>
              </a:path>
            </a:pathLst>
          </a:custGeom>
          <a:noFill/>
          <a:ln w="26988" cap="flat">
            <a:solidFill>
              <a:srgbClr val="D4495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4A4DCA7-C588-9488-242A-93A0FAD23456}"/>
              </a:ext>
            </a:extLst>
          </p:cNvPr>
          <p:cNvSpPr txBox="1"/>
          <p:nvPr/>
        </p:nvSpPr>
        <p:spPr>
          <a:xfrm>
            <a:off x="1271359" y="5971839"/>
            <a:ext cx="974020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LC early-stage (n=53) vs. intermediate-stage (n=47) was not statistically significant based on the log-rank test (P=0.051).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92169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4</TotalTime>
  <Words>101</Words>
  <Application>Microsoft Office PowerPoint</Application>
  <PresentationFormat>ワイド画面</PresentationFormat>
  <Paragraphs>4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naka Takashi</dc:creator>
  <cp:lastModifiedBy>Tanaka Takashi</cp:lastModifiedBy>
  <cp:revision>60</cp:revision>
  <cp:lastPrinted>2021-10-19T09:44:10Z</cp:lastPrinted>
  <dcterms:created xsi:type="dcterms:W3CDTF">2020-04-07T09:59:01Z</dcterms:created>
  <dcterms:modified xsi:type="dcterms:W3CDTF">2023-09-12T11:05:03Z</dcterms:modified>
</cp:coreProperties>
</file>